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8564" autoAdjust="0"/>
  </p:normalViewPr>
  <p:slideViewPr>
    <p:cSldViewPr snapToGrid="0" snapToObjects="1">
      <p:cViewPr varScale="1">
        <p:scale>
          <a:sx n="80" d="100"/>
          <a:sy n="80" d="100"/>
        </p:scale>
        <p:origin x="-3472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DBB16A-8286-1047-948E-62E27815768C}" type="datetimeFigureOut">
              <a:rPr lang="en-US" smtClean="0"/>
              <a:t>5/26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1853DF-6FF5-1B4F-B53F-1DFE75EAA4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35935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01853DF-6FF5-1B4F-B53F-1DFE75EAA46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8139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DC15D-E380-2945-AFE1-8F8A62D3FC59}" type="datetimeFigureOut">
              <a:rPr lang="en-US" smtClean="0"/>
              <a:t>5/26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1C8DE-462E-4F4E-9DCB-EEC3AEEDAC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42737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DC15D-E380-2945-AFE1-8F8A62D3FC59}" type="datetimeFigureOut">
              <a:rPr lang="en-US" smtClean="0"/>
              <a:t>5/26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1C8DE-462E-4F4E-9DCB-EEC3AEEDAC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94045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DC15D-E380-2945-AFE1-8F8A62D3FC59}" type="datetimeFigureOut">
              <a:rPr lang="en-US" smtClean="0"/>
              <a:t>5/26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1C8DE-462E-4F4E-9DCB-EEC3AEEDAC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12240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DC15D-E380-2945-AFE1-8F8A62D3FC59}" type="datetimeFigureOut">
              <a:rPr lang="en-US" smtClean="0"/>
              <a:t>5/26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1C8DE-462E-4F4E-9DCB-EEC3AEEDAC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3350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DC15D-E380-2945-AFE1-8F8A62D3FC59}" type="datetimeFigureOut">
              <a:rPr lang="en-US" smtClean="0"/>
              <a:t>5/26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1C8DE-462E-4F4E-9DCB-EEC3AEEDAC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35710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DC15D-E380-2945-AFE1-8F8A62D3FC59}" type="datetimeFigureOut">
              <a:rPr lang="en-US" smtClean="0"/>
              <a:t>5/26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1C8DE-462E-4F4E-9DCB-EEC3AEEDAC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22415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DC15D-E380-2945-AFE1-8F8A62D3FC59}" type="datetimeFigureOut">
              <a:rPr lang="en-US" smtClean="0"/>
              <a:t>5/26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1C8DE-462E-4F4E-9DCB-EEC3AEEDAC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9413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DC15D-E380-2945-AFE1-8F8A62D3FC59}" type="datetimeFigureOut">
              <a:rPr lang="en-US" smtClean="0"/>
              <a:t>5/26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1C8DE-462E-4F4E-9DCB-EEC3AEEDAC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13565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DC15D-E380-2945-AFE1-8F8A62D3FC59}" type="datetimeFigureOut">
              <a:rPr lang="en-US" smtClean="0"/>
              <a:t>5/26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1C8DE-462E-4F4E-9DCB-EEC3AEEDAC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11455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DC15D-E380-2945-AFE1-8F8A62D3FC59}" type="datetimeFigureOut">
              <a:rPr lang="en-US" smtClean="0"/>
              <a:t>5/26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1C8DE-462E-4F4E-9DCB-EEC3AEEDAC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79535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DC15D-E380-2945-AFE1-8F8A62D3FC59}" type="datetimeFigureOut">
              <a:rPr lang="en-US" smtClean="0"/>
              <a:t>5/26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1C8DE-462E-4F4E-9DCB-EEC3AEEDAC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94868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DDC15D-E380-2945-AFE1-8F8A62D3FC59}" type="datetimeFigureOut">
              <a:rPr lang="en-US" smtClean="0"/>
              <a:t>5/26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F1C8DE-462E-4F4E-9DCB-EEC3AEEDAC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09574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503" y="1437062"/>
            <a:ext cx="6701438" cy="4279392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942130" y="3573375"/>
            <a:ext cx="731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  <a:latin typeface="Arial"/>
                <a:cs typeface="Arial"/>
              </a:rPr>
              <a:t>23%</a:t>
            </a:r>
            <a:endParaRPr lang="en-US" b="1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942130" y="3151562"/>
            <a:ext cx="731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  <a:latin typeface="Arial"/>
                <a:cs typeface="Arial"/>
              </a:rPr>
              <a:t>14%</a:t>
            </a:r>
            <a:endParaRPr lang="en-US" b="1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942130" y="2262178"/>
            <a:ext cx="731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  <a:latin typeface="Arial"/>
                <a:cs typeface="Arial"/>
              </a:rPr>
              <a:t>64%</a:t>
            </a:r>
            <a:endParaRPr lang="en-US" b="1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630073" y="3577296"/>
            <a:ext cx="731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solidFill>
                  <a:schemeClr val="bg1"/>
                </a:solidFill>
                <a:latin typeface="Arial"/>
                <a:cs typeface="Arial"/>
              </a:rPr>
              <a:t>26%</a:t>
            </a:r>
            <a:endParaRPr lang="en-US" b="1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630073" y="3019454"/>
            <a:ext cx="731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solidFill>
                  <a:schemeClr val="bg1"/>
                </a:solidFill>
                <a:latin typeface="Arial"/>
                <a:cs typeface="Arial"/>
              </a:rPr>
              <a:t>17%</a:t>
            </a:r>
            <a:endParaRPr lang="en-US" b="1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630073" y="2170126"/>
            <a:ext cx="731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solidFill>
                  <a:schemeClr val="bg1"/>
                </a:solidFill>
                <a:latin typeface="Arial"/>
                <a:cs typeface="Arial"/>
              </a:rPr>
              <a:t>57%</a:t>
            </a:r>
            <a:endParaRPr lang="en-US" b="1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817362" y="3316603"/>
            <a:ext cx="731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  <a:latin typeface="Arial"/>
                <a:cs typeface="Arial"/>
              </a:rPr>
              <a:t>42%</a:t>
            </a:r>
            <a:endParaRPr lang="en-US" b="1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817362" y="2444803"/>
            <a:ext cx="731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  <a:latin typeface="Arial"/>
                <a:cs typeface="Arial"/>
              </a:rPr>
              <a:t>32%</a:t>
            </a:r>
            <a:endParaRPr lang="en-US" b="1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817362" y="1773361"/>
            <a:ext cx="731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  <a:latin typeface="Arial"/>
                <a:cs typeface="Arial"/>
              </a:rPr>
              <a:t>2</a:t>
            </a:r>
            <a:r>
              <a:rPr lang="en-US" b="1" dirty="0" smtClean="0">
                <a:solidFill>
                  <a:schemeClr val="bg1"/>
                </a:solidFill>
                <a:latin typeface="Arial"/>
                <a:cs typeface="Arial"/>
              </a:rPr>
              <a:t>6</a:t>
            </a:r>
            <a:r>
              <a:rPr lang="en-US" b="1" dirty="0" smtClean="0">
                <a:solidFill>
                  <a:schemeClr val="bg1"/>
                </a:solidFill>
                <a:latin typeface="Arial"/>
                <a:cs typeface="Arial"/>
              </a:rPr>
              <a:t>%</a:t>
            </a:r>
            <a:endParaRPr lang="en-US" b="1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577041" y="3279897"/>
            <a:ext cx="731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  <a:latin typeface="Arial"/>
                <a:cs typeface="Arial"/>
              </a:rPr>
              <a:t>47%</a:t>
            </a:r>
            <a:endParaRPr lang="en-US" b="1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577041" y="2423369"/>
            <a:ext cx="731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  <a:latin typeface="Arial"/>
                <a:cs typeface="Arial"/>
              </a:rPr>
              <a:t>26%</a:t>
            </a:r>
            <a:endParaRPr lang="en-US" b="1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577041" y="1801985"/>
            <a:ext cx="731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  <a:latin typeface="Arial"/>
                <a:cs typeface="Arial"/>
              </a:rPr>
              <a:t>28%</a:t>
            </a:r>
            <a:endParaRPr lang="en-US" b="1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20002" y="5668728"/>
            <a:ext cx="6637938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Figure S1. </a:t>
            </a:r>
            <a:r>
              <a:rPr lang="en-US" dirty="0" smtClean="0">
                <a:latin typeface="Arial"/>
                <a:cs typeface="Arial"/>
              </a:rPr>
              <a:t>Bias of transversion spectra toward C-to-A and G-to-T mutations. The relative percentages of C-to-A, G-to-T, and all other types of transversions (the sum of six mutational types) were determined for both the HIV-1 &amp; 2 biological samples and plasmid controls.  The data represent the average of three experimental replicates.  The actual numbers of read pairs, mutations, and reference bases are listed in Dataset S1.</a:t>
            </a:r>
            <a:endParaRPr lang="en-US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20972315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120</Words>
  <Application>Microsoft Macintosh PowerPoint</Application>
  <PresentationFormat>On-screen Show (4:3)</PresentationFormat>
  <Paragraphs>1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nstitute for Molecular Virolog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sky Lab #12</dc:creator>
  <cp:lastModifiedBy>Jonathan 18-165-1</cp:lastModifiedBy>
  <cp:revision>18</cp:revision>
  <dcterms:created xsi:type="dcterms:W3CDTF">2014-01-08T19:52:40Z</dcterms:created>
  <dcterms:modified xsi:type="dcterms:W3CDTF">2015-05-26T15:59:02Z</dcterms:modified>
</cp:coreProperties>
</file>